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8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8958F-BE9B-4B8B-A4F5-9FDD5FB954E7}" type="datetimeFigureOut">
              <a:rPr lang="en-GB" smtClean="0"/>
              <a:t>08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EE553-6196-4C1D-B72A-219F54BADD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7712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8958F-BE9B-4B8B-A4F5-9FDD5FB954E7}" type="datetimeFigureOut">
              <a:rPr lang="en-GB" smtClean="0"/>
              <a:t>08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EE553-6196-4C1D-B72A-219F54BADD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25738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8958F-BE9B-4B8B-A4F5-9FDD5FB954E7}" type="datetimeFigureOut">
              <a:rPr lang="en-GB" smtClean="0"/>
              <a:t>08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EE553-6196-4C1D-B72A-219F54BADD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4479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8958F-BE9B-4B8B-A4F5-9FDD5FB954E7}" type="datetimeFigureOut">
              <a:rPr lang="en-GB" smtClean="0"/>
              <a:t>08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EE553-6196-4C1D-B72A-219F54BADD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83041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8958F-BE9B-4B8B-A4F5-9FDD5FB954E7}" type="datetimeFigureOut">
              <a:rPr lang="en-GB" smtClean="0"/>
              <a:t>08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EE553-6196-4C1D-B72A-219F54BADD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5005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8958F-BE9B-4B8B-A4F5-9FDD5FB954E7}" type="datetimeFigureOut">
              <a:rPr lang="en-GB" smtClean="0"/>
              <a:t>08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EE553-6196-4C1D-B72A-219F54BADD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11126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8958F-BE9B-4B8B-A4F5-9FDD5FB954E7}" type="datetimeFigureOut">
              <a:rPr lang="en-GB" smtClean="0"/>
              <a:t>08/08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EE553-6196-4C1D-B72A-219F54BADD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2434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8958F-BE9B-4B8B-A4F5-9FDD5FB954E7}" type="datetimeFigureOut">
              <a:rPr lang="en-GB" smtClean="0"/>
              <a:t>08/08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EE553-6196-4C1D-B72A-219F54BADD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83304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8958F-BE9B-4B8B-A4F5-9FDD5FB954E7}" type="datetimeFigureOut">
              <a:rPr lang="en-GB" smtClean="0"/>
              <a:t>08/08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EE553-6196-4C1D-B72A-219F54BADD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22343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8958F-BE9B-4B8B-A4F5-9FDD5FB954E7}" type="datetimeFigureOut">
              <a:rPr lang="en-GB" smtClean="0"/>
              <a:t>08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EE553-6196-4C1D-B72A-219F54BADD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34865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8958F-BE9B-4B8B-A4F5-9FDD5FB954E7}" type="datetimeFigureOut">
              <a:rPr lang="en-GB" smtClean="0"/>
              <a:t>08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EE553-6196-4C1D-B72A-219F54BADD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26687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88958F-BE9B-4B8B-A4F5-9FDD5FB954E7}" type="datetimeFigureOut">
              <a:rPr lang="en-GB" smtClean="0"/>
              <a:t>08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CEE553-6196-4C1D-B72A-219F54BADD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80482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/>
          <p:cNvSpPr/>
          <p:nvPr/>
        </p:nvSpPr>
        <p:spPr>
          <a:xfrm>
            <a:off x="831273" y="842816"/>
            <a:ext cx="2789382" cy="995219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Zoonotic disease prioritisation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" name="Rounded Rectangle 4"/>
          <p:cNvSpPr/>
          <p:nvPr/>
        </p:nvSpPr>
        <p:spPr>
          <a:xfrm>
            <a:off x="831274" y="2744351"/>
            <a:ext cx="2789380" cy="995219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hibitors</a:t>
            </a:r>
            <a:r>
              <a:rPr kumimoji="0" lang="en-GB" sz="1800" b="1" i="0" u="none" strike="noStrike" kern="1200" cap="none" spc="0" normalizeH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" name="Rounded Rectangle 5"/>
          <p:cNvSpPr/>
          <p:nvPr/>
        </p:nvSpPr>
        <p:spPr>
          <a:xfrm>
            <a:off x="842018" y="4468088"/>
            <a:ext cx="2778635" cy="995219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pportunities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" name="Rounded Rectangle 6"/>
          <p:cNvSpPr/>
          <p:nvPr/>
        </p:nvSpPr>
        <p:spPr>
          <a:xfrm>
            <a:off x="4497093" y="641924"/>
            <a:ext cx="3079364" cy="402939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nowledge/evidence</a:t>
            </a:r>
            <a:r>
              <a:rPr kumimoji="0" lang="en-GB" sz="1800" b="1" i="0" u="none" strike="noStrike" kern="1200" cap="none" spc="0" normalizeH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gaps</a:t>
            </a: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" name="Rounded Rectangle 7"/>
          <p:cNvSpPr/>
          <p:nvPr/>
        </p:nvSpPr>
        <p:spPr>
          <a:xfrm>
            <a:off x="4497093" y="1480127"/>
            <a:ext cx="3079364" cy="337130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riteria for prioritisation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" name="Rounded Rectangle 8"/>
          <p:cNvSpPr/>
          <p:nvPr/>
        </p:nvSpPr>
        <p:spPr>
          <a:xfrm>
            <a:off x="4497093" y="2343722"/>
            <a:ext cx="3079364" cy="400629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uman/Institutional barriers 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0" name="Rounded Rectangle 9"/>
          <p:cNvSpPr/>
          <p:nvPr/>
        </p:nvSpPr>
        <p:spPr>
          <a:xfrm>
            <a:off x="4497093" y="3041068"/>
            <a:ext cx="3079364" cy="423717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echnical barriers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1" name="Rounded Rectangle 10"/>
          <p:cNvSpPr/>
          <p:nvPr/>
        </p:nvSpPr>
        <p:spPr>
          <a:xfrm>
            <a:off x="4497093" y="3665676"/>
            <a:ext cx="3079364" cy="487798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inancial barriers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2" name="Rounded Rectangle 11"/>
          <p:cNvSpPr/>
          <p:nvPr/>
        </p:nvSpPr>
        <p:spPr>
          <a:xfrm>
            <a:off x="4497093" y="4439225"/>
            <a:ext cx="3079364" cy="410441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etworks and Partnerships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3" name="Rounded Rectangle 12"/>
          <p:cNvSpPr/>
          <p:nvPr/>
        </p:nvSpPr>
        <p:spPr>
          <a:xfrm>
            <a:off x="4497093" y="5061524"/>
            <a:ext cx="3079364" cy="401783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rust as an intervening factor 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15" name="Straight Connector 14"/>
          <p:cNvCxnSpPr>
            <a:stCxn id="4" idx="3"/>
            <a:endCxn id="7" idx="1"/>
          </p:cNvCxnSpPr>
          <p:nvPr/>
        </p:nvCxnSpPr>
        <p:spPr>
          <a:xfrm flipV="1">
            <a:off x="3620655" y="843394"/>
            <a:ext cx="876438" cy="49703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>
            <a:stCxn id="4" idx="3"/>
            <a:endCxn id="8" idx="1"/>
          </p:cNvCxnSpPr>
          <p:nvPr/>
        </p:nvCxnSpPr>
        <p:spPr>
          <a:xfrm>
            <a:off x="3620655" y="1340426"/>
            <a:ext cx="876438" cy="30826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>
            <a:endCxn id="9" idx="1"/>
          </p:cNvCxnSpPr>
          <p:nvPr/>
        </p:nvCxnSpPr>
        <p:spPr>
          <a:xfrm flipV="1">
            <a:off x="3620653" y="2544037"/>
            <a:ext cx="876440" cy="49703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>
            <a:endCxn id="10" idx="1"/>
          </p:cNvCxnSpPr>
          <p:nvPr/>
        </p:nvCxnSpPr>
        <p:spPr>
          <a:xfrm>
            <a:off x="3620653" y="3041068"/>
            <a:ext cx="876440" cy="21185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>
            <a:endCxn id="11" idx="1"/>
          </p:cNvCxnSpPr>
          <p:nvPr/>
        </p:nvCxnSpPr>
        <p:spPr>
          <a:xfrm>
            <a:off x="3620653" y="3050595"/>
            <a:ext cx="876440" cy="85898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>
            <a:endCxn id="12" idx="1"/>
          </p:cNvCxnSpPr>
          <p:nvPr/>
        </p:nvCxnSpPr>
        <p:spPr>
          <a:xfrm flipV="1">
            <a:off x="3620653" y="4644446"/>
            <a:ext cx="876440" cy="19656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>
            <a:endCxn id="13" idx="1"/>
          </p:cNvCxnSpPr>
          <p:nvPr/>
        </p:nvCxnSpPr>
        <p:spPr>
          <a:xfrm>
            <a:off x="3620653" y="4850820"/>
            <a:ext cx="876440" cy="4115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Rounded Rectangle 39"/>
          <p:cNvSpPr/>
          <p:nvPr/>
        </p:nvSpPr>
        <p:spPr>
          <a:xfrm>
            <a:off x="8055366" y="5043849"/>
            <a:ext cx="3958824" cy="359395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hared understanding of problem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1" name="Rounded Rectangle 40"/>
          <p:cNvSpPr/>
          <p:nvPr/>
        </p:nvSpPr>
        <p:spPr>
          <a:xfrm>
            <a:off x="8073378" y="5573533"/>
            <a:ext cx="3958824" cy="412749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xistence of informal networks</a:t>
            </a: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2" name="Rounded Rectangle 41"/>
          <p:cNvSpPr/>
          <p:nvPr/>
        </p:nvSpPr>
        <p:spPr>
          <a:xfrm>
            <a:off x="8073963" y="6078732"/>
            <a:ext cx="3958824" cy="593575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rust relations key in cross-sectoral</a:t>
            </a:r>
            <a:r>
              <a:rPr kumimoji="0" lang="en-GB" sz="1800" b="1" i="0" u="none" strike="noStrike" kern="1200" cap="none" spc="0" normalizeH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engagement for disease prioritisation</a:t>
            </a: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47" name="Straight Connector 46"/>
          <p:cNvCxnSpPr>
            <a:stCxn id="12" idx="3"/>
            <a:endCxn id="40" idx="1"/>
          </p:cNvCxnSpPr>
          <p:nvPr/>
        </p:nvCxnSpPr>
        <p:spPr>
          <a:xfrm>
            <a:off x="7576457" y="4644446"/>
            <a:ext cx="478909" cy="57910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>
            <a:stCxn id="12" idx="3"/>
            <a:endCxn id="41" idx="1"/>
          </p:cNvCxnSpPr>
          <p:nvPr/>
        </p:nvCxnSpPr>
        <p:spPr>
          <a:xfrm>
            <a:off x="7576457" y="4644446"/>
            <a:ext cx="496921" cy="113546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>
            <a:stCxn id="13" idx="3"/>
            <a:endCxn id="43" idx="1"/>
          </p:cNvCxnSpPr>
          <p:nvPr/>
        </p:nvCxnSpPr>
        <p:spPr>
          <a:xfrm>
            <a:off x="7576457" y="5262416"/>
            <a:ext cx="504319" cy="119132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Rounded Rectangle 53"/>
          <p:cNvSpPr/>
          <p:nvPr/>
        </p:nvSpPr>
        <p:spPr>
          <a:xfrm>
            <a:off x="8060433" y="1924899"/>
            <a:ext cx="3958824" cy="391417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xotic versus endemic diseases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5" name="Rounded Rectangle 54"/>
          <p:cNvSpPr/>
          <p:nvPr/>
        </p:nvSpPr>
        <p:spPr>
          <a:xfrm>
            <a:off x="8043109" y="2476772"/>
            <a:ext cx="3958824" cy="579667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stitutional </a:t>
            </a: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ureaucracies &amp; </a:t>
            </a: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iffering institutional cultures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6" name="Rounded Rectangle 55"/>
          <p:cNvSpPr/>
          <p:nvPr/>
        </p:nvSpPr>
        <p:spPr>
          <a:xfrm>
            <a:off x="8043109" y="3821190"/>
            <a:ext cx="3958824" cy="508180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imited infrastructure &amp; </a:t>
            </a: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rveillance capacity</a:t>
            </a: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7" name="Rounded Rectangle 56"/>
          <p:cNvSpPr/>
          <p:nvPr/>
        </p:nvSpPr>
        <p:spPr>
          <a:xfrm>
            <a:off x="8052346" y="4368239"/>
            <a:ext cx="3958824" cy="540947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Joint prioritisation</a:t>
            </a:r>
            <a:r>
              <a:rPr kumimoji="0" lang="en-GB" sz="1800" b="1" i="0" u="none" strike="noStrike" kern="1200" cap="none" spc="0" normalizeH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en-GB" sz="1800" b="1" i="0" u="none" strike="noStrike" kern="1200" cap="none" spc="0" normalizeH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ifficult due to limited resources </a:t>
            </a: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65" name="Straight Connector 64"/>
          <p:cNvCxnSpPr>
            <a:stCxn id="11" idx="3"/>
            <a:endCxn id="57" idx="1"/>
          </p:cNvCxnSpPr>
          <p:nvPr/>
        </p:nvCxnSpPr>
        <p:spPr>
          <a:xfrm>
            <a:off x="7576457" y="3909575"/>
            <a:ext cx="475889" cy="72913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/>
          <p:cNvCxnSpPr>
            <a:stCxn id="10" idx="3"/>
            <a:endCxn id="59" idx="1"/>
          </p:cNvCxnSpPr>
          <p:nvPr/>
        </p:nvCxnSpPr>
        <p:spPr>
          <a:xfrm>
            <a:off x="7576457" y="3252927"/>
            <a:ext cx="466652" cy="18621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/>
          <p:cNvCxnSpPr>
            <a:endCxn id="56" idx="1"/>
          </p:cNvCxnSpPr>
          <p:nvPr/>
        </p:nvCxnSpPr>
        <p:spPr>
          <a:xfrm>
            <a:off x="7574267" y="3264378"/>
            <a:ext cx="468842" cy="81090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/>
          <p:cNvCxnSpPr>
            <a:stCxn id="8" idx="3"/>
            <a:endCxn id="54" idx="1"/>
          </p:cNvCxnSpPr>
          <p:nvPr/>
        </p:nvCxnSpPr>
        <p:spPr>
          <a:xfrm>
            <a:off x="7576457" y="1648692"/>
            <a:ext cx="483976" cy="47191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/>
          <p:cNvCxnSpPr>
            <a:stCxn id="9" idx="3"/>
            <a:endCxn id="55" idx="1"/>
          </p:cNvCxnSpPr>
          <p:nvPr/>
        </p:nvCxnSpPr>
        <p:spPr>
          <a:xfrm>
            <a:off x="7576457" y="2544037"/>
            <a:ext cx="466652" cy="22256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Rounded Rectangle 91"/>
          <p:cNvSpPr/>
          <p:nvPr/>
        </p:nvSpPr>
        <p:spPr>
          <a:xfrm>
            <a:off x="8082374" y="1040126"/>
            <a:ext cx="3958824" cy="308774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iority diseases of concern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94" name="Straight Connector 93"/>
          <p:cNvCxnSpPr>
            <a:stCxn id="8" idx="3"/>
            <a:endCxn id="92" idx="1"/>
          </p:cNvCxnSpPr>
          <p:nvPr/>
        </p:nvCxnSpPr>
        <p:spPr>
          <a:xfrm flipV="1">
            <a:off x="7576457" y="1194513"/>
            <a:ext cx="505917" cy="45417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Rounded Rectangle 96"/>
          <p:cNvSpPr/>
          <p:nvPr/>
        </p:nvSpPr>
        <p:spPr>
          <a:xfrm>
            <a:off x="8088501" y="404116"/>
            <a:ext cx="3958824" cy="564861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veremphasis</a:t>
            </a:r>
            <a:r>
              <a:rPr kumimoji="0" lang="en-GB" sz="1800" b="1" i="0" u="none" strike="noStrike" kern="1200" cap="none" spc="0" normalizeH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on domestic animal vaccination as opposed to wildlife </a:t>
            </a: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99" name="Straight Connector 98"/>
          <p:cNvCxnSpPr>
            <a:stCxn id="7" idx="3"/>
            <a:endCxn id="97" idx="1"/>
          </p:cNvCxnSpPr>
          <p:nvPr/>
        </p:nvCxnSpPr>
        <p:spPr>
          <a:xfrm flipV="1">
            <a:off x="7576457" y="598582"/>
            <a:ext cx="501299" cy="24481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/>
          <p:cNvCxnSpPr/>
          <p:nvPr/>
        </p:nvCxnSpPr>
        <p:spPr>
          <a:xfrm>
            <a:off x="762481" y="328206"/>
            <a:ext cx="68792" cy="6275794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/>
          <p:cNvCxnSpPr/>
          <p:nvPr/>
        </p:nvCxnSpPr>
        <p:spPr>
          <a:xfrm>
            <a:off x="3609908" y="310735"/>
            <a:ext cx="21490" cy="6293265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/>
          <p:nvPr/>
        </p:nvCxnSpPr>
        <p:spPr>
          <a:xfrm>
            <a:off x="7587202" y="328206"/>
            <a:ext cx="3031" cy="640378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1012371" y="293914"/>
            <a:ext cx="2514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opic</a:t>
            </a: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4460477" y="206660"/>
            <a:ext cx="2514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oot codes</a:t>
            </a: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8556106" y="96830"/>
            <a:ext cx="2514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hild codes</a:t>
            </a: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108" name="Straight Connector 107"/>
          <p:cNvCxnSpPr/>
          <p:nvPr/>
        </p:nvCxnSpPr>
        <p:spPr>
          <a:xfrm>
            <a:off x="12036580" y="177341"/>
            <a:ext cx="9237" cy="6108599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Rounded Rectangle 58"/>
          <p:cNvSpPr/>
          <p:nvPr/>
        </p:nvSpPr>
        <p:spPr>
          <a:xfrm>
            <a:off x="8043109" y="3175085"/>
            <a:ext cx="3958824" cy="528116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imited access to scientific research to inform prioritisation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6" name="Rounded Rectangle 65"/>
          <p:cNvSpPr/>
          <p:nvPr/>
        </p:nvSpPr>
        <p:spPr>
          <a:xfrm>
            <a:off x="8067002" y="1412548"/>
            <a:ext cx="3958824" cy="441551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cidence of diseases,</a:t>
            </a:r>
            <a:r>
              <a:rPr kumimoji="0" lang="en-GB" sz="1800" b="1" i="0" u="none" strike="noStrike" kern="1200" cap="none" spc="0" normalizeH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mortality rates, affected social groups</a:t>
            </a:r>
            <a:endParaRPr kumimoji="0" lang="en-GB" sz="18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68" name="Straight Connector 67"/>
          <p:cNvCxnSpPr>
            <a:stCxn id="8" idx="3"/>
            <a:endCxn id="66" idx="1"/>
          </p:cNvCxnSpPr>
          <p:nvPr/>
        </p:nvCxnSpPr>
        <p:spPr>
          <a:xfrm flipV="1">
            <a:off x="7576457" y="1633324"/>
            <a:ext cx="490545" cy="1536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176884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99</Words>
  <Application>Microsoft Office PowerPoint</Application>
  <PresentationFormat>Widescreen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Centre for Ecology and Hydrolog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estus Asaaga</dc:creator>
  <cp:lastModifiedBy>Festus Asaaga</cp:lastModifiedBy>
  <cp:revision>5</cp:revision>
  <dcterms:created xsi:type="dcterms:W3CDTF">2023-08-08T08:45:12Z</dcterms:created>
  <dcterms:modified xsi:type="dcterms:W3CDTF">2023-08-08T09:36:23Z</dcterms:modified>
</cp:coreProperties>
</file>